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0826750" cy="8120063" type="B4ISO"/>
  <p:notesSz cx="6858000" cy="9144000"/>
  <p:defaultTextStyle>
    <a:defPPr>
      <a:defRPr lang="en-US"/>
    </a:defPPr>
    <a:lvl1pPr marL="0" algn="l" defTabSz="1082631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41316" algn="l" defTabSz="1082631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82631" algn="l" defTabSz="1082631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23947" algn="l" defTabSz="1082631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65263" algn="l" defTabSz="1082631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706578" algn="l" defTabSz="1082631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47894" algn="l" defTabSz="1082631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89210" algn="l" defTabSz="1082631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330525" algn="l" defTabSz="1082631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338" y="-72"/>
      </p:cViewPr>
      <p:guideLst>
        <p:guide orient="horz" pos="2558"/>
        <p:guide pos="341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2007" y="2522484"/>
            <a:ext cx="9202738" cy="174055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4013" y="4601369"/>
            <a:ext cx="7578725" cy="207512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413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826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239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65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7065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478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892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3305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49394" y="325181"/>
            <a:ext cx="2436019" cy="692836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1337" y="325181"/>
            <a:ext cx="7127610" cy="692836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5239" y="5217893"/>
            <a:ext cx="9202738" cy="1612735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5239" y="3441631"/>
            <a:ext cx="9202738" cy="1776263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41316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82631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2394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6526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70657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4789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8921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3305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1338" y="1894683"/>
            <a:ext cx="4781814" cy="5358866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03599" y="1894683"/>
            <a:ext cx="4781814" cy="5358866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9" y="1817617"/>
            <a:ext cx="4783694" cy="757496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1316" indent="0">
              <a:buNone/>
              <a:defRPr sz="2400" b="1"/>
            </a:lvl2pPr>
            <a:lvl3pPr marL="1082631" indent="0">
              <a:buNone/>
              <a:defRPr sz="2100" b="1"/>
            </a:lvl3pPr>
            <a:lvl4pPr marL="1623947" indent="0">
              <a:buNone/>
              <a:defRPr sz="1900" b="1"/>
            </a:lvl4pPr>
            <a:lvl5pPr marL="2165263" indent="0">
              <a:buNone/>
              <a:defRPr sz="1900" b="1"/>
            </a:lvl5pPr>
            <a:lvl6pPr marL="2706578" indent="0">
              <a:buNone/>
              <a:defRPr sz="1900" b="1"/>
            </a:lvl6pPr>
            <a:lvl7pPr marL="3247894" indent="0">
              <a:buNone/>
              <a:defRPr sz="1900" b="1"/>
            </a:lvl7pPr>
            <a:lvl8pPr marL="3789210" indent="0">
              <a:buNone/>
              <a:defRPr sz="1900" b="1"/>
            </a:lvl8pPr>
            <a:lvl9pPr marL="4330525" indent="0">
              <a:buNone/>
              <a:defRPr sz="1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1339" y="2575113"/>
            <a:ext cx="4783694" cy="4678435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99841" y="1817617"/>
            <a:ext cx="4785573" cy="757496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1316" indent="0">
              <a:buNone/>
              <a:defRPr sz="2400" b="1"/>
            </a:lvl2pPr>
            <a:lvl3pPr marL="1082631" indent="0">
              <a:buNone/>
              <a:defRPr sz="2100" b="1"/>
            </a:lvl3pPr>
            <a:lvl4pPr marL="1623947" indent="0">
              <a:buNone/>
              <a:defRPr sz="1900" b="1"/>
            </a:lvl4pPr>
            <a:lvl5pPr marL="2165263" indent="0">
              <a:buNone/>
              <a:defRPr sz="1900" b="1"/>
            </a:lvl5pPr>
            <a:lvl6pPr marL="2706578" indent="0">
              <a:buNone/>
              <a:defRPr sz="1900" b="1"/>
            </a:lvl6pPr>
            <a:lvl7pPr marL="3247894" indent="0">
              <a:buNone/>
              <a:defRPr sz="1900" b="1"/>
            </a:lvl7pPr>
            <a:lvl8pPr marL="3789210" indent="0">
              <a:buNone/>
              <a:defRPr sz="1900" b="1"/>
            </a:lvl8pPr>
            <a:lvl9pPr marL="4330525" indent="0">
              <a:buNone/>
              <a:defRPr sz="1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99841" y="2575113"/>
            <a:ext cx="4785573" cy="4678435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40" y="323299"/>
            <a:ext cx="3561926" cy="1375900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32961" y="323300"/>
            <a:ext cx="6052454" cy="6930249"/>
          </a:xfrm>
        </p:spPr>
        <p:txBody>
          <a:bodyPr/>
          <a:lstStyle>
            <a:lvl1pPr>
              <a:defRPr sz="3800"/>
            </a:lvl1pPr>
            <a:lvl2pPr>
              <a:defRPr sz="3300"/>
            </a:lvl2pPr>
            <a:lvl3pPr>
              <a:defRPr sz="29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1340" y="1699200"/>
            <a:ext cx="3561926" cy="5554350"/>
          </a:xfrm>
        </p:spPr>
        <p:txBody>
          <a:bodyPr/>
          <a:lstStyle>
            <a:lvl1pPr marL="0" indent="0">
              <a:buNone/>
              <a:defRPr sz="1700"/>
            </a:lvl1pPr>
            <a:lvl2pPr marL="541316" indent="0">
              <a:buNone/>
              <a:defRPr sz="1400"/>
            </a:lvl2pPr>
            <a:lvl3pPr marL="1082631" indent="0">
              <a:buNone/>
              <a:defRPr sz="1200"/>
            </a:lvl3pPr>
            <a:lvl4pPr marL="1623947" indent="0">
              <a:buNone/>
              <a:defRPr sz="1100"/>
            </a:lvl4pPr>
            <a:lvl5pPr marL="2165263" indent="0">
              <a:buNone/>
              <a:defRPr sz="1100"/>
            </a:lvl5pPr>
            <a:lvl6pPr marL="2706578" indent="0">
              <a:buNone/>
              <a:defRPr sz="1100"/>
            </a:lvl6pPr>
            <a:lvl7pPr marL="3247894" indent="0">
              <a:buNone/>
              <a:defRPr sz="1100"/>
            </a:lvl7pPr>
            <a:lvl8pPr marL="3789210" indent="0">
              <a:buNone/>
              <a:defRPr sz="1100"/>
            </a:lvl8pPr>
            <a:lvl9pPr marL="4330525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22119" y="5684045"/>
            <a:ext cx="6496050" cy="671033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22119" y="725542"/>
            <a:ext cx="6496050" cy="4872038"/>
          </a:xfrm>
        </p:spPr>
        <p:txBody>
          <a:bodyPr/>
          <a:lstStyle>
            <a:lvl1pPr marL="0" indent="0">
              <a:buNone/>
              <a:defRPr sz="3800"/>
            </a:lvl1pPr>
            <a:lvl2pPr marL="541316" indent="0">
              <a:buNone/>
              <a:defRPr sz="3300"/>
            </a:lvl2pPr>
            <a:lvl3pPr marL="1082631" indent="0">
              <a:buNone/>
              <a:defRPr sz="2900"/>
            </a:lvl3pPr>
            <a:lvl4pPr marL="1623947" indent="0">
              <a:buNone/>
              <a:defRPr sz="2400"/>
            </a:lvl4pPr>
            <a:lvl5pPr marL="2165263" indent="0">
              <a:buNone/>
              <a:defRPr sz="2400"/>
            </a:lvl5pPr>
            <a:lvl6pPr marL="2706578" indent="0">
              <a:buNone/>
              <a:defRPr sz="2400"/>
            </a:lvl6pPr>
            <a:lvl7pPr marL="3247894" indent="0">
              <a:buNone/>
              <a:defRPr sz="2400"/>
            </a:lvl7pPr>
            <a:lvl8pPr marL="3789210" indent="0">
              <a:buNone/>
              <a:defRPr sz="2400"/>
            </a:lvl8pPr>
            <a:lvl9pPr marL="4330525" indent="0">
              <a:buNone/>
              <a:defRPr sz="24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22119" y="6355079"/>
            <a:ext cx="6496050" cy="952979"/>
          </a:xfrm>
        </p:spPr>
        <p:txBody>
          <a:bodyPr/>
          <a:lstStyle>
            <a:lvl1pPr marL="0" indent="0">
              <a:buNone/>
              <a:defRPr sz="1700"/>
            </a:lvl1pPr>
            <a:lvl2pPr marL="541316" indent="0">
              <a:buNone/>
              <a:defRPr sz="1400"/>
            </a:lvl2pPr>
            <a:lvl3pPr marL="1082631" indent="0">
              <a:buNone/>
              <a:defRPr sz="1200"/>
            </a:lvl3pPr>
            <a:lvl4pPr marL="1623947" indent="0">
              <a:buNone/>
              <a:defRPr sz="1100"/>
            </a:lvl4pPr>
            <a:lvl5pPr marL="2165263" indent="0">
              <a:buNone/>
              <a:defRPr sz="1100"/>
            </a:lvl5pPr>
            <a:lvl6pPr marL="2706578" indent="0">
              <a:buNone/>
              <a:defRPr sz="1100"/>
            </a:lvl6pPr>
            <a:lvl7pPr marL="3247894" indent="0">
              <a:buNone/>
              <a:defRPr sz="1100"/>
            </a:lvl7pPr>
            <a:lvl8pPr marL="3789210" indent="0">
              <a:buNone/>
              <a:defRPr sz="1100"/>
            </a:lvl8pPr>
            <a:lvl9pPr marL="4330525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1338" y="325180"/>
            <a:ext cx="9744075" cy="1353344"/>
          </a:xfrm>
          <a:prstGeom prst="rect">
            <a:avLst/>
          </a:prstGeom>
        </p:spPr>
        <p:txBody>
          <a:bodyPr vert="horz" lIns="108263" tIns="54132" rIns="108263" bIns="5413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1894683"/>
            <a:ext cx="9744075" cy="5358866"/>
          </a:xfrm>
          <a:prstGeom prst="rect">
            <a:avLst/>
          </a:prstGeom>
        </p:spPr>
        <p:txBody>
          <a:bodyPr vert="horz" lIns="108263" tIns="54132" rIns="108263" bIns="5413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1338" y="7526096"/>
            <a:ext cx="2526241" cy="432318"/>
          </a:xfrm>
          <a:prstGeom prst="rect">
            <a:avLst/>
          </a:prstGeom>
        </p:spPr>
        <p:txBody>
          <a:bodyPr vert="horz" lIns="108263" tIns="54132" rIns="108263" bIns="54132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99141" y="7526096"/>
            <a:ext cx="3428470" cy="432318"/>
          </a:xfrm>
          <a:prstGeom prst="rect">
            <a:avLst/>
          </a:prstGeom>
        </p:spPr>
        <p:txBody>
          <a:bodyPr vert="horz" lIns="108263" tIns="54132" rIns="108263" bIns="54132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59172" y="7526096"/>
            <a:ext cx="2526241" cy="432318"/>
          </a:xfrm>
          <a:prstGeom prst="rect">
            <a:avLst/>
          </a:prstGeom>
        </p:spPr>
        <p:txBody>
          <a:bodyPr vert="horz" lIns="108263" tIns="54132" rIns="108263" bIns="54132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82631" rtl="0" eaLnBrk="1" latinLnBrk="0" hangingPunct="1">
        <a:spcBef>
          <a:spcPct val="0"/>
        </a:spcBef>
        <a:buNone/>
        <a:defRPr sz="5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987" indent="-405987" algn="l" defTabSz="1082631" rtl="0" eaLnBrk="1" latinLnBrk="0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879638" indent="-338322" algn="l" defTabSz="1082631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53289" indent="-270658" algn="l" defTabSz="1082631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894605" indent="-270658" algn="l" defTabSz="1082631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5920" indent="-270658" algn="l" defTabSz="1082631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77236" indent="-270658" algn="l" defTabSz="1082631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518552" indent="-270658" algn="l" defTabSz="1082631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59867" indent="-270658" algn="l" defTabSz="1082631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601183" indent="-270658" algn="l" defTabSz="1082631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826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41316" algn="l" defTabSz="10826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82631" algn="l" defTabSz="10826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23947" algn="l" defTabSz="10826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65263" algn="l" defTabSz="10826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706578" algn="l" defTabSz="10826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47894" algn="l" defTabSz="10826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89210" algn="l" defTabSz="10826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330525" algn="l" defTabSz="1082631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9" Type="http://schemas.openxmlformats.org/officeDocument/2006/relationships/image" Target="../media/image38.jpeg"/><Relationship Id="rId21" Type="http://schemas.openxmlformats.org/officeDocument/2006/relationships/image" Target="../media/image20.jpeg"/><Relationship Id="rId34" Type="http://schemas.openxmlformats.org/officeDocument/2006/relationships/image" Target="../media/image33.jpeg"/><Relationship Id="rId42" Type="http://schemas.openxmlformats.org/officeDocument/2006/relationships/image" Target="../media/image41.jpeg"/><Relationship Id="rId47" Type="http://schemas.openxmlformats.org/officeDocument/2006/relationships/image" Target="../media/image46.jpeg"/><Relationship Id="rId50" Type="http://schemas.openxmlformats.org/officeDocument/2006/relationships/image" Target="../media/image49.jpeg"/><Relationship Id="rId55" Type="http://schemas.openxmlformats.org/officeDocument/2006/relationships/image" Target="../media/image54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33" Type="http://schemas.openxmlformats.org/officeDocument/2006/relationships/image" Target="../media/image32.jpeg"/><Relationship Id="rId38" Type="http://schemas.openxmlformats.org/officeDocument/2006/relationships/image" Target="../media/image37.jpeg"/><Relationship Id="rId46" Type="http://schemas.openxmlformats.org/officeDocument/2006/relationships/image" Target="../media/image45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41" Type="http://schemas.openxmlformats.org/officeDocument/2006/relationships/image" Target="../media/image40.jpeg"/><Relationship Id="rId54" Type="http://schemas.openxmlformats.org/officeDocument/2006/relationships/image" Target="../media/image5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32" Type="http://schemas.openxmlformats.org/officeDocument/2006/relationships/image" Target="../media/image31.jpeg"/><Relationship Id="rId37" Type="http://schemas.openxmlformats.org/officeDocument/2006/relationships/image" Target="../media/image36.jpeg"/><Relationship Id="rId40" Type="http://schemas.openxmlformats.org/officeDocument/2006/relationships/image" Target="../media/image39.jpeg"/><Relationship Id="rId45" Type="http://schemas.openxmlformats.org/officeDocument/2006/relationships/image" Target="../media/image44.jpeg"/><Relationship Id="rId53" Type="http://schemas.openxmlformats.org/officeDocument/2006/relationships/image" Target="../media/image52.jpeg"/><Relationship Id="rId58" Type="http://schemas.openxmlformats.org/officeDocument/2006/relationships/hyperlink" Target="http://rna.tbi.univie.ac.at/cgi-bin/RNAfold.cgi" TargetMode="External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36" Type="http://schemas.openxmlformats.org/officeDocument/2006/relationships/image" Target="../media/image35.jpeg"/><Relationship Id="rId49" Type="http://schemas.openxmlformats.org/officeDocument/2006/relationships/image" Target="../media/image48.jpeg"/><Relationship Id="rId57" Type="http://schemas.openxmlformats.org/officeDocument/2006/relationships/image" Target="../media/image56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4" Type="http://schemas.openxmlformats.org/officeDocument/2006/relationships/image" Target="../media/image43.jpeg"/><Relationship Id="rId52" Type="http://schemas.openxmlformats.org/officeDocument/2006/relationships/image" Target="../media/image51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Relationship Id="rId35" Type="http://schemas.openxmlformats.org/officeDocument/2006/relationships/image" Target="../media/image34.jpeg"/><Relationship Id="rId43" Type="http://schemas.openxmlformats.org/officeDocument/2006/relationships/image" Target="../media/image42.jpeg"/><Relationship Id="rId48" Type="http://schemas.openxmlformats.org/officeDocument/2006/relationships/image" Target="../media/image47.jpeg"/><Relationship Id="rId56" Type="http://schemas.openxmlformats.org/officeDocument/2006/relationships/image" Target="../media/image55.jpeg"/><Relationship Id="rId8" Type="http://schemas.openxmlformats.org/officeDocument/2006/relationships/image" Target="../media/image7.jpeg"/><Relationship Id="rId51" Type="http://schemas.openxmlformats.org/officeDocument/2006/relationships/image" Target="../media/image50.jpeg"/><Relationship Id="rId3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Soham\Desktop\5th yr project\Diagrams for manuscript\stem loop structure\168\cgr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07" t="46798" b="5650"/>
          <a:stretch/>
        </p:blipFill>
        <p:spPr bwMode="auto">
          <a:xfrm rot="2659979">
            <a:off x="4007251" y="622938"/>
            <a:ext cx="918818" cy="929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6" descr="C:\Users\Soham\Desktop\5th yr project\Diagrams for manuscript\stem loop structure\168\cfl a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392" t="47471" b="7955"/>
          <a:stretch/>
        </p:blipFill>
        <p:spPr bwMode="auto">
          <a:xfrm rot="3060469">
            <a:off x="3412780" y="728084"/>
            <a:ext cx="924468" cy="7832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C:\Users\Soham\Desktop\5th yr project\Diagrams for manuscript\stem loop structure\168\aau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45" r="37979"/>
          <a:stretch/>
        </p:blipFill>
        <p:spPr bwMode="auto">
          <a:xfrm>
            <a:off x="353158" y="383796"/>
            <a:ext cx="280738" cy="1224317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51520" y="1698923"/>
            <a:ext cx="99311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u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2" descr="C:\Users\Soham\Desktop\5th yr project\Diagrams for manuscript\stem loop structure\168\aly a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27" r="40941"/>
          <a:stretch/>
        </p:blipFill>
        <p:spPr bwMode="auto">
          <a:xfrm>
            <a:off x="781967" y="389527"/>
            <a:ext cx="351083" cy="1319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692696" y="1697831"/>
            <a:ext cx="72008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y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</a:p>
        </p:txBody>
      </p:sp>
      <p:pic>
        <p:nvPicPr>
          <p:cNvPr id="8" name="Picture 4" descr="C:\Users\Soham\Desktop\5th yr project\Diagrams for manuscript\stem loop structure\168\ath a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51" r="38560"/>
          <a:stretch/>
        </p:blipFill>
        <p:spPr bwMode="auto">
          <a:xfrm>
            <a:off x="1806573" y="347431"/>
            <a:ext cx="302834" cy="14022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23403" y="1714697"/>
            <a:ext cx="7694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th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</a:p>
        </p:txBody>
      </p:sp>
      <p:pic>
        <p:nvPicPr>
          <p:cNvPr id="10" name="Picture 3" descr="C:\Users\Soham\Desktop\5th yr project\Diagrams for manuscript\stem loop structure\168\aly b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83" r="42549"/>
          <a:stretch/>
        </p:blipFill>
        <p:spPr bwMode="auto">
          <a:xfrm>
            <a:off x="1338742" y="398855"/>
            <a:ext cx="326617" cy="13434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209186" y="1748586"/>
            <a:ext cx="8516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ly- miR168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208655" y="1714832"/>
            <a:ext cx="7694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ath- miR168b</a:t>
            </a:r>
          </a:p>
        </p:txBody>
      </p:sp>
      <p:pic>
        <p:nvPicPr>
          <p:cNvPr id="13" name="Picture 5" descr="C:\Users\Soham\Desktop\5th yr project\Diagrams for manuscript\stem loop structure\168\ath b.jp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44" t="1778" r="40635" b="1"/>
          <a:stretch/>
        </p:blipFill>
        <p:spPr bwMode="auto">
          <a:xfrm>
            <a:off x="2388614" y="344078"/>
            <a:ext cx="295392" cy="13969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8" descr="C:\Users\Soham\Desktop\5th yr project\Diagrams for manuscript\stem loop structure\168\cca a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33" r="43926"/>
          <a:stretch/>
        </p:blipFill>
        <p:spPr bwMode="auto">
          <a:xfrm>
            <a:off x="2930619" y="282949"/>
            <a:ext cx="190079" cy="13933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2690116" y="1683474"/>
            <a:ext cx="7694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c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</a:p>
        </p:txBody>
      </p:sp>
      <p:pic>
        <p:nvPicPr>
          <p:cNvPr id="16" name="Picture 9" descr="C:\Users\Soham\Desktop\5th yr project\Diagrams for manuscript\stem loop structure\168\ccl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88" r="43924"/>
          <a:stretch/>
        </p:blipFill>
        <p:spPr bwMode="auto">
          <a:xfrm>
            <a:off x="3238336" y="263598"/>
            <a:ext cx="229540" cy="14140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3194172" y="1714697"/>
            <a:ext cx="7694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cl- miR168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655752" y="1718628"/>
            <a:ext cx="91942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fl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194175" y="1735505"/>
            <a:ext cx="108012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gr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3" descr="C:\Users\Soham\Desktop\5th yr project\Diagrams for manuscript\stem loop structure\168\chi a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99" t="53773" r="19271"/>
          <a:stretch/>
        </p:blipFill>
        <p:spPr bwMode="auto">
          <a:xfrm rot="1820194">
            <a:off x="4638444" y="444678"/>
            <a:ext cx="787786" cy="11025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4739664" y="1733463"/>
            <a:ext cx="108012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chi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3" descr="C:\Users\Soham\Desktop\5th yr project\Diagrams for manuscript\stem loop structure\168\cir a.jp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965" t="33549" r="24203"/>
          <a:stretch/>
        </p:blipFill>
        <p:spPr bwMode="auto">
          <a:xfrm rot="453570">
            <a:off x="5263084" y="387701"/>
            <a:ext cx="531779" cy="12256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5400055" y="1578021"/>
            <a:ext cx="108012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ir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06757" y="21431"/>
            <a:ext cx="23769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cots (non -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lanaceous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: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4" descr="C:\Users\Soham\Desktop\5th yr project\Diagrams for manuscript\stem loop structure\168\ech a1.jp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92" t="38071" r="25564"/>
          <a:stretch/>
        </p:blipFill>
        <p:spPr bwMode="auto">
          <a:xfrm rot="1338440">
            <a:off x="7378878" y="430198"/>
            <a:ext cx="682388" cy="1219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3" descr="C:\Users\Soham\Desktop\5th yr project\Diagrams for manuscript\stem loop structure\168\crt.jpg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78" t="16105" r="36860"/>
          <a:stretch/>
        </p:blipFill>
        <p:spPr bwMode="auto">
          <a:xfrm rot="20622900">
            <a:off x="6979041" y="458052"/>
            <a:ext cx="462770" cy="1199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2" descr="C:\Users\Soham\Desktop\5th yr project\Diagrams for manuscript\stem loop structure\168\cim a.jp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67" t="49581" r="8927"/>
          <a:stretch/>
        </p:blipFill>
        <p:spPr bwMode="auto">
          <a:xfrm rot="2017421">
            <a:off x="6226967" y="526259"/>
            <a:ext cx="769731" cy="9586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6461650" y="1598902"/>
            <a:ext cx="108012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im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952537" y="1740994"/>
            <a:ext cx="108012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t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492597" y="1688168"/>
            <a:ext cx="73453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h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2" descr="C:\Users\Soham\Desktop\5th yr project\Diagrams for manuscript\stem loop structure\168\gma a.jpg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08" r="40538"/>
          <a:stretch/>
        </p:blipFill>
        <p:spPr bwMode="auto">
          <a:xfrm>
            <a:off x="8082047" y="182774"/>
            <a:ext cx="370090" cy="14894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3" descr="C:\Users\Soham\Desktop\5th yr project\Diagrams for manuscript\stem loop structure\168\gma b.jpg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85" r="43390"/>
          <a:stretch/>
        </p:blipFill>
        <p:spPr bwMode="auto">
          <a:xfrm>
            <a:off x="8697037" y="233410"/>
            <a:ext cx="271347" cy="15188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TextBox 32"/>
          <p:cNvSpPr txBox="1"/>
          <p:nvPr/>
        </p:nvSpPr>
        <p:spPr>
          <a:xfrm>
            <a:off x="8050538" y="1655380"/>
            <a:ext cx="78217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m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577297" y="1739678"/>
            <a:ext cx="78217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m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Picture 5" descr="C:\Users\Soham\Desktop\5th yr project\Diagrams for manuscript\stem loop structure\168\lus a.jpg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75" r="42819"/>
          <a:stretch/>
        </p:blipFill>
        <p:spPr bwMode="auto">
          <a:xfrm>
            <a:off x="9201875" y="178179"/>
            <a:ext cx="315190" cy="1551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9125978" y="1749660"/>
            <a:ext cx="78217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us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Picture 4" descr="C:\Users\Soham\Desktop\5th yr project\Diagrams for manuscript\stem loop structure\168\hvu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82" r="39350"/>
          <a:stretch/>
        </p:blipFill>
        <p:spPr bwMode="auto">
          <a:xfrm>
            <a:off x="9715309" y="138314"/>
            <a:ext cx="385683" cy="15657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TextBox 37"/>
          <p:cNvSpPr txBox="1"/>
          <p:nvPr/>
        </p:nvSpPr>
        <p:spPr>
          <a:xfrm>
            <a:off x="9709905" y="1739677"/>
            <a:ext cx="78217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vu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Picture 6" descr="C:\Users\Soham\Desktop\5th yr project\Diagrams for manuscript\stem loop structure\168\lus b.jpg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78" r="45093"/>
          <a:stretch/>
        </p:blipFill>
        <p:spPr bwMode="auto">
          <a:xfrm>
            <a:off x="10363294" y="96061"/>
            <a:ext cx="257567" cy="16223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7" descr="C:\Users\Soham\Desktop\5th yr project\Diagrams for manuscript\stem loop structure\168\mdm a.jpg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87" r="34336"/>
          <a:stretch/>
        </p:blipFill>
        <p:spPr bwMode="auto">
          <a:xfrm>
            <a:off x="231381" y="2007281"/>
            <a:ext cx="405031" cy="1542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8" descr="C:\Users\Soham\Desktop\5th yr project\Diagrams for manuscript\stem loop structure\168\mdm b.jpg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08" r="46024"/>
          <a:stretch/>
        </p:blipFill>
        <p:spPr bwMode="auto">
          <a:xfrm>
            <a:off x="914525" y="1935273"/>
            <a:ext cx="153935" cy="16873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10310552" y="1718792"/>
            <a:ext cx="62061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us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18315" y="3530241"/>
            <a:ext cx="77813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dm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708420" y="3582945"/>
            <a:ext cx="124906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dm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Picture 2" descr="C:\Users\Soham\Desktop\5th yr project\Diagrams for manuscript\stem loop structure\168\ptu b.jpg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97" t="40818" r="30238"/>
          <a:stretch/>
        </p:blipFill>
        <p:spPr bwMode="auto">
          <a:xfrm rot="402389">
            <a:off x="5913297" y="344909"/>
            <a:ext cx="478010" cy="12326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5899919" y="1589227"/>
            <a:ext cx="711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u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Picture 2" descr="C:\Users\Soham\Desktop\5th yr project\Diagrams for manuscript\stem loop structure\168\vun.jpg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10" r="40776"/>
          <a:stretch/>
        </p:blipFill>
        <p:spPr bwMode="auto">
          <a:xfrm>
            <a:off x="1249645" y="1926431"/>
            <a:ext cx="326261" cy="16138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8" name="TextBox 47"/>
          <p:cNvSpPr txBox="1"/>
          <p:nvPr/>
        </p:nvSpPr>
        <p:spPr>
          <a:xfrm>
            <a:off x="1218874" y="3550807"/>
            <a:ext cx="124906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un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Picture 2" descr="C:\Users\Soham\Desktop\5th yr project\Diagrams for manuscript\stem loop structure\168\ptu a.jpg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97" t="40719" r="12144"/>
          <a:stretch/>
        </p:blipFill>
        <p:spPr bwMode="auto">
          <a:xfrm rot="1712983">
            <a:off x="4200231" y="2331896"/>
            <a:ext cx="638870" cy="9924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4" descr="C:\Users\Soham\Desktop\5th yr project\Diagrams for manuscript\stem loop structure\168\tha.jpg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13" t="45059" r="17721"/>
          <a:stretch/>
        </p:blipFill>
        <p:spPr bwMode="auto">
          <a:xfrm rot="2218741">
            <a:off x="5478682" y="2333645"/>
            <a:ext cx="813455" cy="9515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2" descr="C:\Users\Soham\Desktop\5th yr project\Diagrams for manuscript\stem loop structure\168\rau a.jpg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91" t="45918" r="13917" b="-1"/>
          <a:stretch/>
        </p:blipFill>
        <p:spPr bwMode="auto">
          <a:xfrm rot="2000690">
            <a:off x="6448548" y="2378151"/>
            <a:ext cx="756126" cy="10377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2" descr="C:\Users\Soham\Desktop\5th yr project\Diagrams for manuscript\stem loop structure\168\mma a1.jpg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32" t="38195" r="17245"/>
          <a:stretch/>
        </p:blipFill>
        <p:spPr bwMode="auto">
          <a:xfrm rot="1812612">
            <a:off x="2122821" y="2291985"/>
            <a:ext cx="684821" cy="976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3" name="Picture 2" descr="C:\Users\Soham\Desktop\5th yr project\Diagrams for manuscript\stem loop structure\168\mma a1.jpg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19" t="36780" r="17245"/>
          <a:stretch/>
        </p:blipFill>
        <p:spPr bwMode="auto">
          <a:xfrm rot="1812612">
            <a:off x="2688018" y="2282535"/>
            <a:ext cx="701031" cy="9647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9" descr="C:\Users\Soham\Desktop\5th yr project\Diagrams for manuscript\stem loop structure\168\mes a.jpg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29" t="1784" r="35156"/>
          <a:stretch/>
        </p:blipFill>
        <p:spPr bwMode="auto">
          <a:xfrm>
            <a:off x="1876515" y="2108307"/>
            <a:ext cx="408899" cy="12783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5" name="TextBox 54"/>
          <p:cNvSpPr txBox="1"/>
          <p:nvPr/>
        </p:nvSpPr>
        <p:spPr>
          <a:xfrm>
            <a:off x="1760532" y="3471770"/>
            <a:ext cx="63892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s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262791" y="3371643"/>
            <a:ext cx="750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1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831304" y="3358172"/>
            <a:ext cx="750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2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Picture 5" descr="C:\Users\Soham\Desktop\5th yr project\Diagrams for manuscript\stem loop structure\168\ptc a.jpg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09" r="39869"/>
          <a:stretch/>
        </p:blipFill>
        <p:spPr bwMode="auto">
          <a:xfrm>
            <a:off x="3494928" y="1979793"/>
            <a:ext cx="291247" cy="13854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9" name="TextBox 58"/>
          <p:cNvSpPr txBox="1"/>
          <p:nvPr/>
        </p:nvSpPr>
        <p:spPr>
          <a:xfrm>
            <a:off x="3356367" y="3400334"/>
            <a:ext cx="711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c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Picture 2" descr="C:\Users\Soham\Desktop\5th yr project\Diagrams for manuscript\stem loop structure\168\ptc b.jpg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432" r="45520"/>
          <a:stretch/>
        </p:blipFill>
        <p:spPr bwMode="auto">
          <a:xfrm>
            <a:off x="4090709" y="1969483"/>
            <a:ext cx="155344" cy="14061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1" name="TextBox 60"/>
          <p:cNvSpPr txBox="1"/>
          <p:nvPr/>
        </p:nvSpPr>
        <p:spPr>
          <a:xfrm>
            <a:off x="3806158" y="3393085"/>
            <a:ext cx="711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ptc 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262988" y="3411750"/>
            <a:ext cx="711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u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6587227" y="3543924"/>
            <a:ext cx="711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u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Picture 2" descr="C:\Users\Soham\Desktop\5th yr project\Diagrams for manuscript\stem loop structure\168\rco.jpg"/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25" r="44534"/>
          <a:stretch/>
        </p:blipFill>
        <p:spPr bwMode="auto">
          <a:xfrm>
            <a:off x="4917940" y="2044722"/>
            <a:ext cx="199603" cy="13934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5" name="TextBox 64"/>
          <p:cNvSpPr txBox="1"/>
          <p:nvPr/>
        </p:nvSpPr>
        <p:spPr>
          <a:xfrm>
            <a:off x="4808690" y="3421274"/>
            <a:ext cx="711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co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Picture 2" descr="C:\Users\Soham\Desktop\5th yr project\Diagrams for manuscript\stem loop structure\168\tcc.jpg"/>
          <p:cNvPicPr>
            <a:picLocks noChangeAspect="1" noChangeArrowheads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72" r="41489"/>
          <a:stretch/>
        </p:blipFill>
        <p:spPr bwMode="auto">
          <a:xfrm>
            <a:off x="5302483" y="2047219"/>
            <a:ext cx="259044" cy="13972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TextBox 66"/>
          <p:cNvSpPr txBox="1"/>
          <p:nvPr/>
        </p:nvSpPr>
        <p:spPr>
          <a:xfrm>
            <a:off x="5230775" y="3457419"/>
            <a:ext cx="711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cc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664459" y="3485596"/>
            <a:ext cx="711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Picture 3" descr="C:\Users\Soham\Desktop\5th yr project\Diagrams for manuscript\stem loop structure\168\tha b.jpg"/>
          <p:cNvPicPr>
            <a:picLocks noChangeAspect="1" noChangeArrowheads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61" t="29322" r="18671"/>
          <a:stretch/>
        </p:blipFill>
        <p:spPr bwMode="auto">
          <a:xfrm rot="321059">
            <a:off x="6025832" y="2217101"/>
            <a:ext cx="501547" cy="11505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0" name="TextBox 69"/>
          <p:cNvSpPr txBox="1"/>
          <p:nvPr/>
        </p:nvSpPr>
        <p:spPr>
          <a:xfrm>
            <a:off x="6114697" y="3439746"/>
            <a:ext cx="7119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" name="Picture 6" descr="C:\Users\Soham\Desktop\5th yr project\Diagrams for manuscript\stem loop structure\168\bna a.jpg"/>
          <p:cNvPicPr>
            <a:picLocks noChangeAspect="1" noChangeArrowheads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690" t="1445" r="46611"/>
          <a:stretch/>
        </p:blipFill>
        <p:spPr bwMode="auto">
          <a:xfrm>
            <a:off x="7897977" y="2154396"/>
            <a:ext cx="158221" cy="15231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2" name="TextBox 71"/>
          <p:cNvSpPr txBox="1"/>
          <p:nvPr/>
        </p:nvSpPr>
        <p:spPr>
          <a:xfrm>
            <a:off x="7629991" y="3638991"/>
            <a:ext cx="7694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</a:p>
        </p:txBody>
      </p:sp>
      <p:pic>
        <p:nvPicPr>
          <p:cNvPr id="73" name="Picture 7" descr="C:\Users\Soham\Desktop\5th yr project\Diagrams for manuscript\stem loop structure\168\bna b.jpg"/>
          <p:cNvPicPr>
            <a:picLocks noChangeAspect="1" noChangeArrowheads="1"/>
          </p:cNvPicPr>
          <p:nvPr/>
        </p:nvPicPr>
        <p:blipFill rotWithShape="1"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89" r="43924"/>
          <a:stretch/>
        </p:blipFill>
        <p:spPr bwMode="auto">
          <a:xfrm>
            <a:off x="8269430" y="2111371"/>
            <a:ext cx="278419" cy="15186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4" name="TextBox 73"/>
          <p:cNvSpPr txBox="1"/>
          <p:nvPr/>
        </p:nvSpPr>
        <p:spPr>
          <a:xfrm>
            <a:off x="8109243" y="3628563"/>
            <a:ext cx="7694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b</a:t>
            </a:r>
          </a:p>
        </p:txBody>
      </p:sp>
      <p:pic>
        <p:nvPicPr>
          <p:cNvPr id="75" name="Picture 3" descr="C:\Users\Soham\Desktop\5th yr project\Diagrams for manuscript\stem loop structure\168\vvi.jpg"/>
          <p:cNvPicPr>
            <a:picLocks noChangeAspect="1" noChangeArrowheads="1"/>
          </p:cNvPicPr>
          <p:nvPr/>
        </p:nvPicPr>
        <p:blipFill rotWithShape="1"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26" r="35547"/>
          <a:stretch/>
        </p:blipFill>
        <p:spPr bwMode="auto">
          <a:xfrm>
            <a:off x="7097925" y="2113949"/>
            <a:ext cx="422513" cy="15234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6" name="TextBox 75"/>
          <p:cNvSpPr txBox="1"/>
          <p:nvPr/>
        </p:nvSpPr>
        <p:spPr>
          <a:xfrm>
            <a:off x="7018459" y="3637355"/>
            <a:ext cx="5752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vvi 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Picture 2" descr="C:\Users\Soham\Desktop\5th yr project\Diagrams for manuscript\stem loop structure\168\mtr a.jpg"/>
          <p:cNvPicPr>
            <a:picLocks noChangeAspect="1" noChangeArrowheads="1"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20" r="41728"/>
          <a:stretch/>
        </p:blipFill>
        <p:spPr bwMode="auto">
          <a:xfrm>
            <a:off x="8682252" y="2122739"/>
            <a:ext cx="295264" cy="15058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8" name="Picture 3" descr="C:\Users\Soham\Desktop\5th yr project\Diagrams for manuscript\stem loop structure\168\mtr b.jpg"/>
          <p:cNvPicPr>
            <a:picLocks noChangeAspect="1" noChangeArrowheads="1"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95" r="40538"/>
          <a:stretch/>
        </p:blipFill>
        <p:spPr bwMode="auto">
          <a:xfrm rot="21365347">
            <a:off x="9097516" y="2140753"/>
            <a:ext cx="335361" cy="14556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9" name="Picture 4" descr="C:\Users\Soham\Desktop\5th yr project\Diagrams for manuscript\stem loop structure\168\mtr c.jpg"/>
          <p:cNvPicPr>
            <a:picLocks noChangeAspect="1" noChangeArrowheads="1"/>
          </p:cNvPicPr>
          <p:nvPr/>
        </p:nvPicPr>
        <p:blipFill rotWithShape="1"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31" r="40301"/>
          <a:stretch/>
        </p:blipFill>
        <p:spPr bwMode="auto">
          <a:xfrm>
            <a:off x="9543628" y="2142245"/>
            <a:ext cx="364523" cy="14863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0" name="TextBox 79"/>
          <p:cNvSpPr txBox="1"/>
          <p:nvPr/>
        </p:nvSpPr>
        <p:spPr>
          <a:xfrm>
            <a:off x="8553671" y="3606140"/>
            <a:ext cx="7694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r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9029134" y="3592915"/>
            <a:ext cx="7694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r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b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9495931" y="3598740"/>
            <a:ext cx="7694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r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c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1052737" y="4528838"/>
            <a:ext cx="11630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onocots: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4" name="Picture 83" descr="C:\Users\Soham\Desktop\5th yr project\Diagrams for manuscript\stem loop structure\168\bna b.jpg"/>
          <p:cNvPicPr>
            <a:picLocks noChangeAspect="1" noChangeArrowheads="1"/>
          </p:cNvPicPr>
          <p:nvPr/>
        </p:nvPicPr>
        <p:blipFill rotWithShape="1"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97" r="40538"/>
          <a:stretch/>
        </p:blipFill>
        <p:spPr bwMode="auto">
          <a:xfrm>
            <a:off x="6385681" y="3962131"/>
            <a:ext cx="399171" cy="14246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5" name="TextBox 84"/>
          <p:cNvSpPr txBox="1"/>
          <p:nvPr/>
        </p:nvSpPr>
        <p:spPr>
          <a:xfrm>
            <a:off x="6233982" y="5380803"/>
            <a:ext cx="10720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b</a:t>
            </a:r>
          </a:p>
        </p:txBody>
      </p:sp>
      <p:pic>
        <p:nvPicPr>
          <p:cNvPr id="86" name="Picture 3" descr="C:\Users\Soham\Desktop\5th yr project\Diagrams for manuscript\stem loop structure\168\sbi.jpg"/>
          <p:cNvPicPr>
            <a:picLocks noChangeAspect="1" noChangeArrowheads="1"/>
          </p:cNvPicPr>
          <p:nvPr/>
        </p:nvPicPr>
        <p:blipFill rotWithShape="1"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60" r="41489"/>
          <a:stretch/>
        </p:blipFill>
        <p:spPr bwMode="auto">
          <a:xfrm>
            <a:off x="6902182" y="3989987"/>
            <a:ext cx="290787" cy="13547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7" name="TextBox 86"/>
          <p:cNvSpPr txBox="1"/>
          <p:nvPr/>
        </p:nvSpPr>
        <p:spPr>
          <a:xfrm>
            <a:off x="6770002" y="5363283"/>
            <a:ext cx="975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bi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7267186" y="5459134"/>
            <a:ext cx="102398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9" name="Picture 2" descr="C:\Users\Soham\Desktop\5th yr project\Diagrams for manuscript\stem loop structure\168\bna a.jpg"/>
          <p:cNvPicPr>
            <a:picLocks noChangeAspect="1" noChangeArrowheads="1"/>
          </p:cNvPicPr>
          <p:nvPr/>
        </p:nvPicPr>
        <p:blipFill rotWithShape="1"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49" t="235" r="37379" b="-235"/>
          <a:stretch/>
        </p:blipFill>
        <p:spPr bwMode="auto">
          <a:xfrm>
            <a:off x="7351896" y="3851969"/>
            <a:ext cx="393875" cy="14968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5" descr="C:\Users\Soham\Desktop\5th yr project\Diagrams for manuscript\stem loop structure\168\zma b.jpg"/>
          <p:cNvPicPr>
            <a:picLocks noChangeAspect="1" noChangeArrowheads="1"/>
          </p:cNvPicPr>
          <p:nvPr/>
        </p:nvPicPr>
        <p:blipFill rotWithShape="1"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99" r="41012"/>
          <a:stretch/>
        </p:blipFill>
        <p:spPr bwMode="auto">
          <a:xfrm>
            <a:off x="7944102" y="3905455"/>
            <a:ext cx="275889" cy="14767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1" name="TextBox 90"/>
          <p:cNvSpPr txBox="1"/>
          <p:nvPr/>
        </p:nvSpPr>
        <p:spPr>
          <a:xfrm>
            <a:off x="7741867" y="5332265"/>
            <a:ext cx="13459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m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" name="Picture 6" descr="C:\Users\Soham\Desktop\5th yr project\Diagrams for manuscript\stem loop structure\168\sof a.jpg"/>
          <p:cNvPicPr>
            <a:picLocks noChangeAspect="1" noChangeArrowheads="1"/>
          </p:cNvPicPr>
          <p:nvPr/>
        </p:nvPicPr>
        <p:blipFill rotWithShape="1"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59" r="43740"/>
          <a:stretch/>
        </p:blipFill>
        <p:spPr bwMode="auto">
          <a:xfrm>
            <a:off x="2394989" y="3978471"/>
            <a:ext cx="277995" cy="15444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3" name="TextBox 92"/>
          <p:cNvSpPr txBox="1"/>
          <p:nvPr/>
        </p:nvSpPr>
        <p:spPr>
          <a:xfrm>
            <a:off x="2215834" y="5484777"/>
            <a:ext cx="132195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f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Picture 7" descr="C:\Users\Soham\Desktop\5th yr project\Diagrams for manuscript\stem loop structure\168\ssp.jpg"/>
          <p:cNvPicPr>
            <a:picLocks noChangeAspect="1" noChangeArrowheads="1"/>
          </p:cNvPicPr>
          <p:nvPr/>
        </p:nvPicPr>
        <p:blipFill rotWithShape="1"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60" r="43153"/>
          <a:stretch/>
        </p:blipFill>
        <p:spPr bwMode="auto">
          <a:xfrm flipH="1">
            <a:off x="2950520" y="3952092"/>
            <a:ext cx="312034" cy="15941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5" name="TextBox 94"/>
          <p:cNvSpPr txBox="1"/>
          <p:nvPr/>
        </p:nvSpPr>
        <p:spPr>
          <a:xfrm>
            <a:off x="2774021" y="5542492"/>
            <a:ext cx="104133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sp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6" name="Picture 5" descr="C:\Users\Soham\Desktop\5th yr project\Diagrams for manuscript\stem loop structure\168\zma b.jpg"/>
          <p:cNvPicPr>
            <a:picLocks noChangeAspect="1" noChangeArrowheads="1"/>
          </p:cNvPicPr>
          <p:nvPr/>
        </p:nvPicPr>
        <p:blipFill rotWithShape="1"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99" r="41012"/>
          <a:stretch/>
        </p:blipFill>
        <p:spPr bwMode="auto">
          <a:xfrm>
            <a:off x="3567651" y="3974258"/>
            <a:ext cx="275889" cy="14767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7" name="TextBox 96"/>
          <p:cNvSpPr txBox="1"/>
          <p:nvPr/>
        </p:nvSpPr>
        <p:spPr>
          <a:xfrm>
            <a:off x="3384983" y="5448470"/>
            <a:ext cx="13459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m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8" name="Picture 4" descr="C:\Users\Soham\Desktop\5th yr project\Diagrams for manuscript\stem loop structure\168\hvu.jpg"/>
          <p:cNvPicPr>
            <a:picLocks noChangeAspect="1" noChangeArrowheads="1"/>
          </p:cNvPicPr>
          <p:nvPr/>
        </p:nvPicPr>
        <p:blipFill rotWithShape="1"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82" r="39350"/>
          <a:stretch/>
        </p:blipFill>
        <p:spPr bwMode="auto">
          <a:xfrm rot="404481">
            <a:off x="4118888" y="3958426"/>
            <a:ext cx="374660" cy="1431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9" name="TextBox 98"/>
          <p:cNvSpPr txBox="1"/>
          <p:nvPr/>
        </p:nvSpPr>
        <p:spPr>
          <a:xfrm>
            <a:off x="4011239" y="5413862"/>
            <a:ext cx="106089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vu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Picture 99" descr="C:\Users\Soham\Desktop\5th yr project\Diagrams for manuscript\stem loop structure\168\bdi.jpg"/>
          <p:cNvPicPr>
            <a:picLocks noChangeAspect="1" noChangeArrowheads="1"/>
          </p:cNvPicPr>
          <p:nvPr/>
        </p:nvPicPr>
        <p:blipFill rotWithShape="1"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33" r="27868"/>
          <a:stretch/>
        </p:blipFill>
        <p:spPr bwMode="auto">
          <a:xfrm rot="20857850">
            <a:off x="4611620" y="4072628"/>
            <a:ext cx="755234" cy="13126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1" name="TextBox 100"/>
          <p:cNvSpPr txBox="1"/>
          <p:nvPr/>
        </p:nvSpPr>
        <p:spPr>
          <a:xfrm>
            <a:off x="4545399" y="5403540"/>
            <a:ext cx="92883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-  miR168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" name="Picture 2" descr="C:\Users\Soham\Desktop\5th yr project\Diagrams for manuscript\stem loop structure\168\osa a.jpg"/>
          <p:cNvPicPr>
            <a:picLocks noChangeAspect="1" noChangeArrowheads="1"/>
          </p:cNvPicPr>
          <p:nvPr/>
        </p:nvPicPr>
        <p:blipFill rotWithShape="1"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49" r="38175"/>
          <a:stretch/>
        </p:blipFill>
        <p:spPr bwMode="auto">
          <a:xfrm>
            <a:off x="5259773" y="3934801"/>
            <a:ext cx="352621" cy="1490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3" name="TextBox 102"/>
          <p:cNvSpPr txBox="1"/>
          <p:nvPr/>
        </p:nvSpPr>
        <p:spPr>
          <a:xfrm>
            <a:off x="5079306" y="5414387"/>
            <a:ext cx="132195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s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4" name="Picture 3" descr="C:\Users\Soham\Desktop\5th yr project\Diagrams for manuscript\stem loop structure\168\osa b.jpg"/>
          <p:cNvPicPr>
            <a:picLocks noChangeAspect="1" noChangeArrowheads="1"/>
          </p:cNvPicPr>
          <p:nvPr/>
        </p:nvPicPr>
        <p:blipFill rotWithShape="1">
          <a:blip r:embed="rId5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50" r="38372"/>
          <a:stretch/>
        </p:blipFill>
        <p:spPr bwMode="auto">
          <a:xfrm>
            <a:off x="5834370" y="3813593"/>
            <a:ext cx="346694" cy="15633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5" name="TextBox 104"/>
          <p:cNvSpPr txBox="1"/>
          <p:nvPr/>
        </p:nvSpPr>
        <p:spPr>
          <a:xfrm>
            <a:off x="5706152" y="5376925"/>
            <a:ext cx="132195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s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6" name="Picture 4" descr="C:\Users\Soham\Desktop\5th yr project\Diagrams for manuscript\stem loop structure\168\nta c.jpg"/>
          <p:cNvPicPr>
            <a:picLocks noChangeAspect="1" noChangeArrowheads="1"/>
          </p:cNvPicPr>
          <p:nvPr/>
        </p:nvPicPr>
        <p:blipFill rotWithShape="1"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99" t="1784" r="29605"/>
          <a:stretch/>
        </p:blipFill>
        <p:spPr bwMode="auto">
          <a:xfrm>
            <a:off x="3915377" y="5733262"/>
            <a:ext cx="703568" cy="18139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" name="Picture 2" descr="C:\Users\Soham\Desktop\5th yr project\Diagrams for manuscript\stem loop structure\168\nta a.jpg"/>
          <p:cNvPicPr>
            <a:picLocks noChangeAspect="1" noChangeArrowheads="1"/>
          </p:cNvPicPr>
          <p:nvPr/>
        </p:nvPicPr>
        <p:blipFill rotWithShape="1">
          <a:blip r:embed="rId5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63" r="28416"/>
          <a:stretch/>
        </p:blipFill>
        <p:spPr bwMode="auto">
          <a:xfrm>
            <a:off x="2214600" y="5824103"/>
            <a:ext cx="738239" cy="18149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8" name="TextBox 107"/>
          <p:cNvSpPr txBox="1"/>
          <p:nvPr/>
        </p:nvSpPr>
        <p:spPr>
          <a:xfrm>
            <a:off x="2189579" y="7494841"/>
            <a:ext cx="124906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t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9" name="Picture 3" descr="C:\Users\Soham\Desktop\5th yr project\Diagrams for manuscript\stem loop structure\168\nta b.jpg"/>
          <p:cNvPicPr>
            <a:picLocks noChangeAspect="1" noChangeArrowheads="1"/>
          </p:cNvPicPr>
          <p:nvPr/>
        </p:nvPicPr>
        <p:blipFill rotWithShape="1"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58" t="2022" r="23663"/>
          <a:stretch/>
        </p:blipFill>
        <p:spPr bwMode="auto">
          <a:xfrm>
            <a:off x="2960003" y="5824103"/>
            <a:ext cx="815442" cy="1692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0" name="TextBox 109"/>
          <p:cNvSpPr txBox="1"/>
          <p:nvPr/>
        </p:nvSpPr>
        <p:spPr>
          <a:xfrm>
            <a:off x="3055586" y="7504556"/>
            <a:ext cx="124906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t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4140709" y="7393164"/>
            <a:ext cx="667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t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c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2" name="Picture 5" descr="C:\Users\Soham\Desktop\5th yr project\Diagrams for manuscript\stem loop structure\168\sly b.jpg"/>
          <p:cNvPicPr>
            <a:picLocks noChangeAspect="1" noChangeArrowheads="1"/>
          </p:cNvPicPr>
          <p:nvPr/>
        </p:nvPicPr>
        <p:blipFill rotWithShape="1">
          <a:blip r:embed="rId5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38" r="40029"/>
          <a:stretch/>
        </p:blipFill>
        <p:spPr bwMode="auto">
          <a:xfrm>
            <a:off x="7120090" y="5896204"/>
            <a:ext cx="377136" cy="14454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3" name="Picture 4" descr="C:\Users\Soham\Desktop\5th yr project\Diagrams for manuscript\stem loop structure\168\sly a.jpg"/>
          <p:cNvPicPr>
            <a:picLocks noChangeAspect="1" noChangeArrowheads="1"/>
          </p:cNvPicPr>
          <p:nvPr/>
        </p:nvPicPr>
        <p:blipFill rotWithShape="1">
          <a:blip r:embed="rId5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15" r="33170"/>
          <a:stretch/>
        </p:blipFill>
        <p:spPr bwMode="auto">
          <a:xfrm>
            <a:off x="7733695" y="5868580"/>
            <a:ext cx="562083" cy="14726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4" name="TextBox 113"/>
          <p:cNvSpPr txBox="1"/>
          <p:nvPr/>
        </p:nvSpPr>
        <p:spPr>
          <a:xfrm>
            <a:off x="6997788" y="7390375"/>
            <a:ext cx="808102" cy="1748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sly - miR168a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7742394" y="7324324"/>
            <a:ext cx="79347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sly - miR168b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6" name="Picture 5" descr="C:\Users\Soham\Desktop\5th yr project\Diagrams for manuscript\stem loop structure\168\nta d.jpg"/>
          <p:cNvPicPr>
            <a:picLocks noChangeAspect="1" noChangeArrowheads="1"/>
          </p:cNvPicPr>
          <p:nvPr/>
        </p:nvPicPr>
        <p:blipFill rotWithShape="1">
          <a:blip r:embed="rId5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95" t="2497" r="35000"/>
          <a:stretch/>
        </p:blipFill>
        <p:spPr bwMode="auto">
          <a:xfrm>
            <a:off x="4808690" y="5728832"/>
            <a:ext cx="656234" cy="20055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7" name="TextBox 116"/>
          <p:cNvSpPr txBox="1"/>
          <p:nvPr/>
        </p:nvSpPr>
        <p:spPr>
          <a:xfrm>
            <a:off x="5039642" y="5896204"/>
            <a:ext cx="67259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t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d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8" name="Picture 2" descr="C:\Users\Soham\Desktop\5th yr project\Diagrams for manuscript\stem loop structure\168\nta e.jpg"/>
          <p:cNvPicPr>
            <a:picLocks noChangeAspect="1" noChangeArrowheads="1"/>
          </p:cNvPicPr>
          <p:nvPr/>
        </p:nvPicPr>
        <p:blipFill rotWithShape="1"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95" r="10712"/>
          <a:stretch/>
        </p:blipFill>
        <p:spPr bwMode="auto">
          <a:xfrm>
            <a:off x="5509612" y="5557873"/>
            <a:ext cx="1571625" cy="2062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9" name="TextBox 118"/>
          <p:cNvSpPr txBox="1"/>
          <p:nvPr/>
        </p:nvSpPr>
        <p:spPr>
          <a:xfrm>
            <a:off x="6020416" y="6646961"/>
            <a:ext cx="83796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ta</a:t>
            </a:r>
            <a:r>
              <a:rPr lang="en-US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- miR168e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068460" y="6339297"/>
            <a:ext cx="11630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lanaceae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mbers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Rectangle 120"/>
          <p:cNvSpPr/>
          <p:nvPr/>
        </p:nvSpPr>
        <p:spPr>
          <a:xfrm>
            <a:off x="77974" y="7675794"/>
            <a:ext cx="1041410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Figure S4.</a:t>
            </a:r>
            <a:r>
              <a:rPr lang="en-US" sz="1200" dirty="0" smtClean="0"/>
              <a:t>  </a:t>
            </a:r>
            <a:r>
              <a:rPr lang="en-US" sz="1200" dirty="0"/>
              <a:t>Secondary structures of 58 precursors of miR168 indicating clade-specific changes in the loop region.  miR168 sequences have been colored in red. Secondary structures were obtained using RNA fold program (</a:t>
            </a:r>
            <a:r>
              <a:rPr lang="en-US" sz="1200" u="sng" dirty="0">
                <a:hlinkClick r:id="rId58"/>
              </a:rPr>
              <a:t>http://rna.tbi.univie.ac.at/cgi-bin/RNAfold.cgi</a:t>
            </a:r>
            <a:r>
              <a:rPr lang="en-US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444798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95</Words>
  <Application>Microsoft Office PowerPoint</Application>
  <PresentationFormat>B4 (ISO) Paper (250x353 mm)</PresentationFormat>
  <Paragraphs>6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6</cp:revision>
  <dcterms:created xsi:type="dcterms:W3CDTF">2006-08-16T00:00:00Z</dcterms:created>
  <dcterms:modified xsi:type="dcterms:W3CDTF">2014-08-25T07:03:19Z</dcterms:modified>
</cp:coreProperties>
</file>